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48" r:id="rId2"/>
    <p:sldId id="295" r:id="rId3"/>
    <p:sldId id="447" r:id="rId4"/>
    <p:sldId id="441" r:id="rId5"/>
    <p:sldId id="437" r:id="rId6"/>
    <p:sldId id="435" r:id="rId7"/>
    <p:sldId id="438" r:id="rId8"/>
    <p:sldId id="298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129" d="100"/>
          <a:sy n="129" d="100"/>
        </p:scale>
        <p:origin x="110" y="3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52B123-E5C8-E05A-493D-4D47EE3C91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03CD664-8D08-63A5-EC16-1A2D3953D3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577652-56B9-AC7B-45F7-B70662B30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566244-7F5E-1FB7-CD86-1B3868C68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20C696-7578-8F36-207D-1A5C0F095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5573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310595-56B6-F3FB-6EEA-D15BA211B3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846CC4-A523-7AE1-942D-836AF36948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678ED-4DD1-B2AB-E2A6-166588811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2FD49F-4C7F-C49C-F939-F17BDBD8C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5E38BD-1B2F-CE76-D6A8-7A70C4921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74471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40B0A2-1C43-79F0-FBC1-BB1CE8C95F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8189F6-16A4-63BE-D820-9416E495C2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890B0B-E6D4-A3B3-E65F-5EBADB93B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AA50A3-364F-747D-2C82-EF3B88B43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B989D1-AB82-AF0E-DC4D-F6A1AA0E2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55241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3612EA-4B02-5C2B-369F-5811F281E9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EC18E9-E67C-5705-8AA8-3F577D2231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FFDFF9-7A4C-770C-2CBD-C426B0617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1A49FD-128B-F38F-81EC-B0DE14DB7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757F0E-F97A-BF50-A7EB-4D69D35B0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43635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ACBE63-EE07-FFAE-362C-0A2502326E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93610F-8B51-F8F8-149B-E988D28EF5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0CFC5A-8384-4A02-9205-79A8FA546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36264F-794B-D0EC-B231-352819547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BA9589-13F0-3F96-14E9-E48E958421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10082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E359AC-4713-9D1F-C13A-20141E2696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30BEE7-A30C-B1A9-E0FE-64150C9425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55601F-6384-C55E-CFC4-23B9EA368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F8C3C6-BDCE-C001-0F23-B58EF0DDF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1FA92-B9F1-7425-A66B-21796BB8E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9CD470-36CE-7211-9384-EE491E45F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14473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DD68BB-4324-A35B-EBE5-6228CB6F05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567714-F254-B2FF-9B68-2CB011D0A9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611AC8-EA62-F0EB-3587-324347BACB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29FF50-7F24-681C-FA41-0E2B49055A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557F47-5153-509F-5266-3DDDD3ED6B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9B9CE3-C3DE-B4B0-7549-C9245FA57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9156CFD-C559-0A38-DA5C-C7689E64D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42F3C9D-0427-870E-570C-BE28EA218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04243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6E893-4D8B-F6AA-DCCF-0DDC5C97BF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F4AFE9-924B-8856-F2FC-79A6AFFD3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F93956E-DFC8-0009-0A58-57E7A96ED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E38C92E-5F74-5102-4C0D-9E6111CDF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15233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AF2B11A-FE06-5BC8-3175-5A7F30733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CA7C8C-0E6B-7532-03CB-386442DCFF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CEB884-781C-701E-A176-FA934BB51A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73439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9F1249-0473-31B1-52CE-818DA404CE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6C575E-AA2E-83D8-109C-4058BD7851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9204A0-65D8-4B18-32B3-D0F29EDAD5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B97747-3C35-2945-6307-87B8FDA54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3CC69A-F4BF-9BE7-8DBC-6CE941871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F66C09-B34C-CB5A-26F3-77BE181B6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6609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02E61A-0ECA-49B8-CDD5-E1CE02EFAB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FC96E9-B034-F554-2E3D-3AF13538CC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B40E4C-E36E-FEC9-B877-3B0D258DA1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04B0A-A3D3-B37B-9F3F-5F85823C9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E9C1D1-C284-C212-95F9-A4C96335F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2C7709-76BD-506F-F1DB-901365E166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64326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1F9D4B-EFC9-9ECB-DB1A-FE3B62FC70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43DD7F-B9C5-63CA-3F23-7AA6803BCD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E4EBB5-800F-D5F0-011E-DDB5079F23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BE0D1-4158-46E2-96A7-B028EFCBB8B1}" type="datetimeFigureOut">
              <a:rPr lang="en-CA" smtClean="0"/>
              <a:t>2023-01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BA591D-A7F2-D87F-0B58-C7F3632278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96D071-8B9B-A810-7CF5-0998B159E0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F82318-6F7C-4036-BE85-3A3BA7D1854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5113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vijay.gadkar@cw.bc.ca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2578D853-C910-13EA-A3B9-BC27522CFF87}"/>
              </a:ext>
            </a:extLst>
          </p:cNvPr>
          <p:cNvSpPr txBox="1"/>
          <p:nvPr/>
        </p:nvSpPr>
        <p:spPr>
          <a:xfrm>
            <a:off x="112919" y="88085"/>
            <a:ext cx="13230942" cy="65081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CA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xtraction-free Clinical Detection of SARS-CoV-2 Virus from Saline Gargle Samples using Hamilton STARlet Liquid Handler 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2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en-CA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ijay J. Gadkar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,2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, David M. Goldfarb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,2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Ghada N. Al-Rawahi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,2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Jocelyn A. Srigley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,2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Duane Smailus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Robin Coope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Stephen Pleasance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Nicole Watson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Tammy Chen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Sunny Lam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Linda Hoang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,4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Peter A.G Tilley</a:t>
            </a: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,2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partment of Pathology &amp; Laboratory Medicine, Division of Microbiology, Virology &amp; Infection Control, BC Children’s and Women’s Hospital + Sunny Health Center, Vancouver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partment of Pathology &amp; Laboratory Medicine, Faculty of Medicine, University of British Columbia, Vancouver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anada’s Michael Smith Genome Science Centre at BC Cancer, 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C Cancer Research Institute, 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ancouver British Columbia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</a:t>
            </a: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ublic Health Laboratory, British Columbia Centre for Disease Control, Vancouver.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Corresponding author: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ddress for correspondence: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oom No 2K9, Department of Pathology &amp; Laboratory Medicine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ivision of Microbiology, Virology &amp; Infection Control 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C Children’s and Women’s Hospital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500 Oak St, Vancouver V6H 3N1 Canada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mail: </a:t>
            </a:r>
            <a:r>
              <a:rPr lang="en-US" sz="1050" u="sng" dirty="0">
                <a:solidFill>
                  <a:srgbClr val="0563C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  <a:hlinkClick r:id="rId2"/>
              </a:rPr>
              <a:t>vijay.gadkar@cw.bc.ca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el: (604) 875-2000 (Ext: 7490)</a:t>
            </a:r>
            <a:endParaRPr lang="en-CA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CA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ax: (604)-875-3777</a:t>
            </a:r>
            <a:b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endParaRPr lang="en-CA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844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46B84D86-BE88-D29E-CCC7-72D9CD4B92C0}"/>
              </a:ext>
            </a:extLst>
          </p:cNvPr>
          <p:cNvGrpSpPr/>
          <p:nvPr/>
        </p:nvGrpSpPr>
        <p:grpSpPr>
          <a:xfrm>
            <a:off x="782792" y="768521"/>
            <a:ext cx="10206545" cy="4135658"/>
            <a:chOff x="1208094" y="2267712"/>
            <a:chExt cx="10206545" cy="4135658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1675DD95-D28A-49E8-A0C8-AD91D212DF6C}"/>
                </a:ext>
              </a:extLst>
            </p:cNvPr>
            <p:cNvGrpSpPr/>
            <p:nvPr/>
          </p:nvGrpSpPr>
          <p:grpSpPr>
            <a:xfrm>
              <a:off x="1208094" y="2267712"/>
              <a:ext cx="9722606" cy="2435161"/>
              <a:chOff x="1098366" y="1636776"/>
              <a:chExt cx="9722606" cy="2435161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0C20BDB5-153F-4D12-9D94-6063A719E0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1098366" y="1636776"/>
                <a:ext cx="9722606" cy="2435161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AAC787EB-F13D-48CA-9E19-72CB89520D74}"/>
                  </a:ext>
                </a:extLst>
              </p:cNvPr>
              <p:cNvSpPr txBox="1"/>
              <p:nvPr/>
            </p:nvSpPr>
            <p:spPr>
              <a:xfrm>
                <a:off x="4840611" y="2798064"/>
                <a:ext cx="83548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b="1" dirty="0">
                    <a:solidFill>
                      <a:srgbClr val="FF0000"/>
                    </a:solidFill>
                  </a:rPr>
                  <a:t>RNase P-R</a:t>
                </a:r>
              </a:p>
            </p:txBody>
          </p:sp>
        </p:grp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355411FB-F854-4359-AD47-449D8FD0E328}"/>
                </a:ext>
              </a:extLst>
            </p:cNvPr>
            <p:cNvSpPr/>
            <p:nvPr/>
          </p:nvSpPr>
          <p:spPr>
            <a:xfrm>
              <a:off x="2731946" y="3196206"/>
              <a:ext cx="3148737" cy="939851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9DE7F64-7471-4CF5-BBE5-8740EAEB4FBA}"/>
                </a:ext>
              </a:extLst>
            </p:cNvPr>
            <p:cNvSpPr txBox="1"/>
            <p:nvPr/>
          </p:nvSpPr>
          <p:spPr>
            <a:xfrm>
              <a:off x="2849380" y="3375231"/>
              <a:ext cx="8194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RNase P-F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751ED4E-882A-452C-9630-E357AA4661A8}"/>
                </a:ext>
              </a:extLst>
            </p:cNvPr>
            <p:cNvSpPr txBox="1"/>
            <p:nvPr/>
          </p:nvSpPr>
          <p:spPr>
            <a:xfrm>
              <a:off x="3730581" y="3652230"/>
              <a:ext cx="10230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RNase P-NED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9384993" y="4406954"/>
              <a:ext cx="1496291" cy="2493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D77A906-34B9-4F45-865B-C65BF2A19150}"/>
                </a:ext>
              </a:extLst>
            </p:cNvPr>
            <p:cNvSpPr txBox="1"/>
            <p:nvPr/>
          </p:nvSpPr>
          <p:spPr>
            <a:xfrm>
              <a:off x="1334326" y="5941705"/>
              <a:ext cx="18473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CA" sz="2400" b="1" dirty="0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9918348" y="5107828"/>
              <a:ext cx="1496291" cy="24938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AC787EB-F13D-48CA-9E19-72CB89520D74}"/>
                </a:ext>
              </a:extLst>
            </p:cNvPr>
            <p:cNvSpPr txBox="1"/>
            <p:nvPr/>
          </p:nvSpPr>
          <p:spPr>
            <a:xfrm>
              <a:off x="10035426" y="3705999"/>
              <a:ext cx="9492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RNase P R-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AC787EB-F13D-48CA-9E19-72CB89520D74}"/>
                </a:ext>
              </a:extLst>
            </p:cNvPr>
            <p:cNvSpPr txBox="1"/>
            <p:nvPr/>
          </p:nvSpPr>
          <p:spPr>
            <a:xfrm>
              <a:off x="10012376" y="4371245"/>
              <a:ext cx="9492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RNase P R-3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AC787EB-F13D-48CA-9E19-72CB89520D74}"/>
                </a:ext>
              </a:extLst>
            </p:cNvPr>
            <p:cNvSpPr txBox="1"/>
            <p:nvPr/>
          </p:nvSpPr>
          <p:spPr>
            <a:xfrm>
              <a:off x="3167335" y="4232745"/>
              <a:ext cx="25752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b="1" dirty="0"/>
                <a:t>RNaseP TaqMan™  (US-CDC)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F129D42D-2D26-6EAE-49BE-6856D79E68D5}"/>
              </a:ext>
            </a:extLst>
          </p:cNvPr>
          <p:cNvSpPr txBox="1"/>
          <p:nvPr/>
        </p:nvSpPr>
        <p:spPr>
          <a:xfrm>
            <a:off x="389862" y="4904179"/>
            <a:ext cx="1152569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800" b="1" dirty="0"/>
              <a:t>Fig. 1_suppl</a:t>
            </a:r>
          </a:p>
          <a:p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ctorial depiction of the alignment of the “low efficiency” RNaseP R-3 primer to the human RNaseP (Ref GenBank Acc: NM_001104546.2). Binding site for RNaseP-F/R and RNaseP (Ned) TaqMan™ assay (US-CDC) is also depicted. The binding </a:t>
            </a:r>
          </a:p>
          <a:p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te of the RNaseP R-3 primer is approximately 150 bp downstream of the RNaseP-R binding site.</a:t>
            </a:r>
          </a:p>
          <a:p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3606034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10281805" y="2858524"/>
            <a:ext cx="15726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b="1" dirty="0"/>
              <a:t>Empty plate</a:t>
            </a:r>
          </a:p>
          <a:p>
            <a:pPr algn="ctr"/>
            <a:r>
              <a:rPr lang="en-US" b="1" dirty="0"/>
              <a:t>(Intermediate)</a:t>
            </a:r>
            <a:endParaRPr lang="en-CA" b="1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048D902D-040B-7998-2F76-3CA6F6EE8DD6}"/>
              </a:ext>
            </a:extLst>
          </p:cNvPr>
          <p:cNvGrpSpPr/>
          <p:nvPr/>
        </p:nvGrpSpPr>
        <p:grpSpPr>
          <a:xfrm>
            <a:off x="377805" y="158634"/>
            <a:ext cx="11436390" cy="6281001"/>
            <a:chOff x="371475" y="224968"/>
            <a:chExt cx="11436390" cy="6281001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71475" y="2744700"/>
              <a:ext cx="2257224" cy="151928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10281805" y="4556407"/>
              <a:ext cx="152606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b="1" dirty="0"/>
                <a:t>SARS-CoV-2</a:t>
              </a:r>
            </a:p>
            <a:p>
              <a:pPr algn="ctr"/>
              <a:r>
                <a:rPr lang="en-CA" b="1" dirty="0"/>
                <a:t>Assay mixture</a:t>
              </a:r>
            </a:p>
          </p:txBody>
        </p:sp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5055" y="936795"/>
              <a:ext cx="6367724" cy="46525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4" name="Straight Arrow Connector 13"/>
            <p:cNvCxnSpPr/>
            <p:nvPr/>
          </p:nvCxnSpPr>
          <p:spPr>
            <a:xfrm>
              <a:off x="8448502" y="3181177"/>
              <a:ext cx="1833303" cy="1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>
              <a:off x="8353252" y="4879573"/>
              <a:ext cx="1928553" cy="8312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538189" y="4371741"/>
              <a:ext cx="19237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Primary collection tube</a:t>
              </a:r>
              <a:endParaRPr lang="en-CA" sz="14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080664" y="258120"/>
              <a:ext cx="35860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ecapped primary collection tubes on tracks</a:t>
              </a:r>
              <a:endParaRPr lang="en-CA" sz="1400" b="1" dirty="0"/>
            </a:p>
          </p:txBody>
        </p:sp>
        <p:cxnSp>
          <p:nvCxnSpPr>
            <p:cNvPr id="24" name="Straight Arrow Connector 23"/>
            <p:cNvCxnSpPr/>
            <p:nvPr/>
          </p:nvCxnSpPr>
          <p:spPr>
            <a:xfrm>
              <a:off x="7699583" y="6367469"/>
              <a:ext cx="267789" cy="0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>
              <a:off x="7483378" y="4525629"/>
              <a:ext cx="793674" cy="1388539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Rectangle 30"/>
            <p:cNvSpPr/>
            <p:nvPr/>
          </p:nvSpPr>
          <p:spPr>
            <a:xfrm>
              <a:off x="7272459" y="4326111"/>
              <a:ext cx="210918" cy="353466"/>
            </a:xfrm>
            <a:prstGeom prst="rect">
              <a:avLst/>
            </a:prstGeom>
            <a:noFill/>
            <a:ln w="25400">
              <a:solidFill>
                <a:schemeClr val="accent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7272458" y="4676956"/>
              <a:ext cx="210920" cy="353466"/>
            </a:xfrm>
            <a:prstGeom prst="rect">
              <a:avLst/>
            </a:prstGeom>
            <a:noFill/>
            <a:ln w="25400">
              <a:solidFill>
                <a:schemeClr val="accent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903545" y="5860927"/>
              <a:ext cx="7897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OS CTRL</a:t>
              </a:r>
              <a:endParaRPr lang="en-CA" sz="1200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903545" y="6228970"/>
              <a:ext cx="8035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NEG CTRL</a:t>
              </a:r>
              <a:endParaRPr lang="en-CA" sz="1200" b="1" dirty="0"/>
            </a:p>
          </p:txBody>
        </p:sp>
        <p:cxnSp>
          <p:nvCxnSpPr>
            <p:cNvPr id="44" name="Straight Connector 43"/>
            <p:cNvCxnSpPr/>
            <p:nvPr/>
          </p:nvCxnSpPr>
          <p:spPr>
            <a:xfrm>
              <a:off x="7377918" y="5030422"/>
              <a:ext cx="321665" cy="1383441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Rectangle 47"/>
            <p:cNvSpPr/>
            <p:nvPr/>
          </p:nvSpPr>
          <p:spPr>
            <a:xfrm>
              <a:off x="5080664" y="224968"/>
              <a:ext cx="3422472" cy="374083"/>
            </a:xfrm>
            <a:prstGeom prst="rect">
              <a:avLst/>
            </a:prstGeom>
            <a:noFill/>
            <a:ln w="31750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57" name="Down Arrow 56"/>
            <p:cNvSpPr/>
            <p:nvPr/>
          </p:nvSpPr>
          <p:spPr>
            <a:xfrm>
              <a:off x="7285751" y="687429"/>
              <a:ext cx="242316" cy="299707"/>
            </a:xfrm>
            <a:prstGeom prst="downArrow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58" name="Down Arrow 57"/>
            <p:cNvSpPr/>
            <p:nvPr/>
          </p:nvSpPr>
          <p:spPr>
            <a:xfrm>
              <a:off x="6879351" y="675955"/>
              <a:ext cx="242316" cy="299707"/>
            </a:xfrm>
            <a:prstGeom prst="downArrow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59" name="Down Arrow 58"/>
            <p:cNvSpPr/>
            <p:nvPr/>
          </p:nvSpPr>
          <p:spPr>
            <a:xfrm>
              <a:off x="6510696" y="675956"/>
              <a:ext cx="242316" cy="299707"/>
            </a:xfrm>
            <a:prstGeom prst="downArrow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60" name="Down Arrow 59"/>
            <p:cNvSpPr/>
            <p:nvPr/>
          </p:nvSpPr>
          <p:spPr>
            <a:xfrm>
              <a:off x="6107759" y="675957"/>
              <a:ext cx="242316" cy="299707"/>
            </a:xfrm>
            <a:prstGeom prst="downArrow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4829658" y="5529896"/>
              <a:ext cx="28558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Loading track   </a:t>
              </a:r>
              <a:r>
                <a:rPr lang="en-US" b="1" dirty="0"/>
                <a:t>1      2     3     4 </a:t>
              </a:r>
              <a:endParaRPr lang="en-CA" b="1" dirty="0"/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6B51E7F6-43D1-504A-7FB2-65B8A8A3040C}"/>
              </a:ext>
            </a:extLst>
          </p:cNvPr>
          <p:cNvSpPr txBox="1"/>
          <p:nvPr/>
        </p:nvSpPr>
        <p:spPr>
          <a:xfrm>
            <a:off x="2049506" y="6439635"/>
            <a:ext cx="876682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. 2_Suppl: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yout of the HGDirect-PCR workflow on the Hamilton STARlet instrument. </a:t>
            </a:r>
          </a:p>
          <a:p>
            <a:endParaRPr lang="en-CA" b="1" dirty="0"/>
          </a:p>
        </p:txBody>
      </p:sp>
    </p:spTree>
    <p:extLst>
      <p:ext uri="{BB962C8B-B14F-4D97-AF65-F5344CB8AC3E}">
        <p14:creationId xmlns:p14="http://schemas.microsoft.com/office/powerpoint/2010/main" val="24184752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5189438"/>
              </p:ext>
            </p:extLst>
          </p:nvPr>
        </p:nvGraphicFramePr>
        <p:xfrm>
          <a:off x="3284686" y="652643"/>
          <a:ext cx="4663440" cy="2892832"/>
        </p:xfrm>
        <a:graphic>
          <a:graphicData uri="http://schemas.openxmlformats.org/drawingml/2006/table">
            <a:tbl>
              <a:tblPr firstRow="1" firstCol="1" bandRow="1"/>
              <a:tblGrid>
                <a:gridCol w="388620">
                  <a:extLst>
                    <a:ext uri="{9D8B030D-6E8A-4147-A177-3AD203B41FA5}">
                      <a16:colId xmlns:a16="http://schemas.microsoft.com/office/drawing/2014/main" val="2985602207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3719690140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4245380590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2603385549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1653714323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182926013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2743451252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1302871919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1112589571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3098733300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1270880293"/>
                    </a:ext>
                  </a:extLst>
                </a:gridCol>
                <a:gridCol w="388620">
                  <a:extLst>
                    <a:ext uri="{9D8B030D-6E8A-4147-A177-3AD203B41FA5}">
                      <a16:colId xmlns:a16="http://schemas.microsoft.com/office/drawing/2014/main" val="1384810890"/>
                    </a:ext>
                  </a:extLst>
                </a:gridCol>
              </a:tblGrid>
              <a:tr h="3616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8659640"/>
                  </a:ext>
                </a:extLst>
              </a:tr>
              <a:tr h="3616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9494519"/>
                  </a:ext>
                </a:extLst>
              </a:tr>
              <a:tr h="3616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485904"/>
                  </a:ext>
                </a:extLst>
              </a:tr>
              <a:tr h="3616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626159"/>
                  </a:ext>
                </a:extLst>
              </a:tr>
              <a:tr h="3616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6816837"/>
                  </a:ext>
                </a:extLst>
              </a:tr>
              <a:tr h="3616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361259"/>
                  </a:ext>
                </a:extLst>
              </a:tr>
              <a:tr h="3616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3201089"/>
                  </a:ext>
                </a:extLst>
              </a:tr>
              <a:tr h="3616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CA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580246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D77A906-34B9-4F45-865B-C65BF2A19150}"/>
              </a:ext>
            </a:extLst>
          </p:cNvPr>
          <p:cNvSpPr txBox="1"/>
          <p:nvPr/>
        </p:nvSpPr>
        <p:spPr>
          <a:xfrm>
            <a:off x="629093" y="5066361"/>
            <a:ext cx="11810999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b="1" dirty="0"/>
              <a:t>Fig. 3_suppl: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quer board-dispensing profile used for cross contamination check (96-well plate). </a:t>
            </a:r>
          </a:p>
          <a:p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cohort of SARS-CoV-2 positive gargle samples (n=12), inserted at the 10th, 13th and 16th position of the four</a:t>
            </a:r>
          </a:p>
          <a:p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milton STARlet’s loading racks, resulted in the dispensing of the sample (red box). The white box depicts dispensing</a:t>
            </a:r>
          </a:p>
          <a:p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SARS-CoV-2 negative sample.</a:t>
            </a:r>
            <a:endParaRPr lang="en-CA" sz="24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842092" y="2511146"/>
            <a:ext cx="495300" cy="4476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8842092" y="3229591"/>
            <a:ext cx="476250" cy="4572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318342" y="2511146"/>
            <a:ext cx="15505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= SARS=CoV-2 </a:t>
            </a:r>
          </a:p>
          <a:p>
            <a:r>
              <a:rPr lang="en-CA" dirty="0"/>
              <a:t>    POSITIV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310613" y="3229591"/>
            <a:ext cx="15505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= SARS=CoV-2 </a:t>
            </a:r>
          </a:p>
          <a:p>
            <a:r>
              <a:rPr lang="en-CA" dirty="0"/>
              <a:t>       NEG</a:t>
            </a:r>
          </a:p>
        </p:txBody>
      </p:sp>
    </p:spTree>
    <p:extLst>
      <p:ext uri="{BB962C8B-B14F-4D97-AF65-F5344CB8AC3E}">
        <p14:creationId xmlns:p14="http://schemas.microsoft.com/office/powerpoint/2010/main" val="25468163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5147CC0-A9A9-2006-D9AE-A0946E790C65}"/>
              </a:ext>
            </a:extLst>
          </p:cNvPr>
          <p:cNvGrpSpPr/>
          <p:nvPr/>
        </p:nvGrpSpPr>
        <p:grpSpPr>
          <a:xfrm>
            <a:off x="291510" y="5210"/>
            <a:ext cx="7184958" cy="3581400"/>
            <a:chOff x="2552700" y="0"/>
            <a:chExt cx="7184958" cy="35814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6F1458C-B3CF-4AA1-B35B-EB3CBA42AB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552700" y="0"/>
              <a:ext cx="7086600" cy="3581400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ABA8BA0-D1B9-4AC9-8382-88F9A0AAE93B}"/>
                </a:ext>
              </a:extLst>
            </p:cNvPr>
            <p:cNvSpPr txBox="1"/>
            <p:nvPr/>
          </p:nvSpPr>
          <p:spPr>
            <a:xfrm>
              <a:off x="7698082" y="366961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1.0 °C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2026B2F-2FBB-47D1-9FB0-AB91E7CFE0A6}"/>
                </a:ext>
              </a:extLst>
            </p:cNvPr>
            <p:cNvSpPr txBox="1"/>
            <p:nvPr/>
          </p:nvSpPr>
          <p:spPr>
            <a:xfrm>
              <a:off x="9120289" y="364454"/>
              <a:ext cx="5116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0 °C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D9FDDA3-854C-42B9-B8B2-EFDA6A6F82F7}"/>
                </a:ext>
              </a:extLst>
            </p:cNvPr>
            <p:cNvSpPr txBox="1"/>
            <p:nvPr/>
          </p:nvSpPr>
          <p:spPr>
            <a:xfrm>
              <a:off x="9087259" y="502244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2.0 °C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23A8232-8A2F-4FE9-8ABC-4BC31E8055EB}"/>
                </a:ext>
              </a:extLst>
            </p:cNvPr>
            <p:cNvSpPr txBox="1"/>
            <p:nvPr/>
          </p:nvSpPr>
          <p:spPr>
            <a:xfrm>
              <a:off x="9105754" y="634323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4.0 °C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0FC629F-3F5F-4D24-8BFF-CEC3AF8E0DE4}"/>
                </a:ext>
              </a:extLst>
            </p:cNvPr>
            <p:cNvSpPr txBox="1"/>
            <p:nvPr/>
          </p:nvSpPr>
          <p:spPr>
            <a:xfrm>
              <a:off x="8242790" y="829196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6.4 °C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F89F426-5274-40B3-BE38-DBCF7E955780}"/>
                </a:ext>
              </a:extLst>
            </p:cNvPr>
            <p:cNvSpPr txBox="1"/>
            <p:nvPr/>
          </p:nvSpPr>
          <p:spPr>
            <a:xfrm>
              <a:off x="7765826" y="1738623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8.4 °C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8707589-D258-42B3-B013-622818BD13DD}"/>
                </a:ext>
              </a:extLst>
            </p:cNvPr>
            <p:cNvSpPr txBox="1"/>
            <p:nvPr/>
          </p:nvSpPr>
          <p:spPr>
            <a:xfrm>
              <a:off x="8558742" y="2269027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9.5 °C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800107D-E20D-45F6-A167-25FC91020E27}"/>
                </a:ext>
              </a:extLst>
            </p:cNvPr>
            <p:cNvSpPr txBox="1"/>
            <p:nvPr/>
          </p:nvSpPr>
          <p:spPr>
            <a:xfrm>
              <a:off x="8789802" y="2724647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70.0 °C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B2FE759-4CFF-4E2C-B1CA-E59B9E1D9F2F}"/>
                </a:ext>
              </a:extLst>
            </p:cNvPr>
            <p:cNvSpPr txBox="1"/>
            <p:nvPr/>
          </p:nvSpPr>
          <p:spPr>
            <a:xfrm>
              <a:off x="3259643" y="317578"/>
              <a:ext cx="7697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b="1" u="sng" dirty="0"/>
                <a:t>SPIKE 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4E3ECD77-C35C-EDD2-773B-EAC222082854}"/>
              </a:ext>
            </a:extLst>
          </p:cNvPr>
          <p:cNvGrpSpPr/>
          <p:nvPr/>
        </p:nvGrpSpPr>
        <p:grpSpPr>
          <a:xfrm>
            <a:off x="129472" y="3314791"/>
            <a:ext cx="7284057" cy="3581400"/>
            <a:chOff x="2405789" y="3276600"/>
            <a:chExt cx="7284057" cy="35814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81468C8-4847-4B2E-99E9-CB4B676B39E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405789" y="3276600"/>
              <a:ext cx="7233511" cy="358140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A844E0D-61B3-4CC4-9065-B35FD99D886D}"/>
                </a:ext>
              </a:extLst>
            </p:cNvPr>
            <p:cNvSpPr txBox="1"/>
            <p:nvPr/>
          </p:nvSpPr>
          <p:spPr>
            <a:xfrm>
              <a:off x="9057942" y="3496919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1.0 °C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83A5433-D357-4433-A5D0-A2A05776B1BF}"/>
                </a:ext>
              </a:extLst>
            </p:cNvPr>
            <p:cNvSpPr txBox="1"/>
            <p:nvPr/>
          </p:nvSpPr>
          <p:spPr>
            <a:xfrm>
              <a:off x="9118055" y="3658578"/>
              <a:ext cx="5116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0 °C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E51CE8B-4FE2-485A-AFB9-D8DC106E35D1}"/>
                </a:ext>
              </a:extLst>
            </p:cNvPr>
            <p:cNvSpPr txBox="1"/>
            <p:nvPr/>
          </p:nvSpPr>
          <p:spPr>
            <a:xfrm>
              <a:off x="9021462" y="3852453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2.0 °C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61C83F3-BFE9-4A01-9581-82A88E96D952}"/>
                </a:ext>
              </a:extLst>
            </p:cNvPr>
            <p:cNvSpPr txBox="1"/>
            <p:nvPr/>
          </p:nvSpPr>
          <p:spPr>
            <a:xfrm>
              <a:off x="8741991" y="4428253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4.0 °C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544CCA7-23CC-48F4-8C74-ED653D97712B}"/>
                </a:ext>
              </a:extLst>
            </p:cNvPr>
            <p:cNvSpPr txBox="1"/>
            <p:nvPr/>
          </p:nvSpPr>
          <p:spPr>
            <a:xfrm>
              <a:off x="8637402" y="5328662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8.4 °C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3265E02-94A0-4178-9CD9-BD321103834E}"/>
                </a:ext>
              </a:extLst>
            </p:cNvPr>
            <p:cNvSpPr txBox="1"/>
            <p:nvPr/>
          </p:nvSpPr>
          <p:spPr>
            <a:xfrm>
              <a:off x="8789802" y="5003083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6.4 °C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80C9C98-8F87-4A43-9E2A-AC7B3CA4A7C1}"/>
                </a:ext>
              </a:extLst>
            </p:cNvPr>
            <p:cNvSpPr txBox="1"/>
            <p:nvPr/>
          </p:nvSpPr>
          <p:spPr>
            <a:xfrm>
              <a:off x="8741991" y="5682839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69.5 °C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6566524-517C-4E01-9C79-CCD1C485572B}"/>
                </a:ext>
              </a:extLst>
            </p:cNvPr>
            <p:cNvSpPr txBox="1"/>
            <p:nvPr/>
          </p:nvSpPr>
          <p:spPr>
            <a:xfrm>
              <a:off x="8874694" y="5974535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rgbClr val="FF0000"/>
                  </a:solidFill>
                </a:rPr>
                <a:t>70.0 °C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2A6F001-D824-4CAE-8118-16FE2A13CAE0}"/>
                </a:ext>
              </a:extLst>
            </p:cNvPr>
            <p:cNvSpPr txBox="1"/>
            <p:nvPr/>
          </p:nvSpPr>
          <p:spPr>
            <a:xfrm>
              <a:off x="3170539" y="3714312"/>
              <a:ext cx="6928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b="1" u="sng" dirty="0"/>
                <a:t>ORF8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9D77A906-34B9-4F45-865B-C65BF2A19150}"/>
              </a:ext>
            </a:extLst>
          </p:cNvPr>
          <p:cNvSpPr txBox="1"/>
          <p:nvPr/>
        </p:nvSpPr>
        <p:spPr>
          <a:xfrm>
            <a:off x="7423096" y="2844282"/>
            <a:ext cx="4795223" cy="1692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/>
              <a:t>Fig. 4_Suppl: </a:t>
            </a:r>
            <a:r>
              <a:rPr lang="en-CA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example of S/ORF8 amplification, tested</a:t>
            </a:r>
          </a:p>
          <a:p>
            <a:r>
              <a:rPr lang="en-CA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using standard method (purified RNA) using SORP ver:1 assay. Variation</a:t>
            </a:r>
          </a:p>
          <a:p>
            <a:r>
              <a:rPr lang="en-CA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S and ORF8 gene signal intensity, at different annealing temperatures</a:t>
            </a:r>
          </a:p>
          <a:p>
            <a:r>
              <a:rPr lang="en-CA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60 °C to 68 °C) quantified in relative fluorescence units (RFU). </a:t>
            </a:r>
          </a:p>
          <a:p>
            <a:r>
              <a:rPr lang="en-CA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 specified by the manufacturer of the Luna Probe One-Step RT-qPCR</a:t>
            </a:r>
          </a:p>
          <a:p>
            <a:r>
              <a:rPr lang="en-CA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x, 60 °C was considered as the optimal annealing temperature and </a:t>
            </a:r>
          </a:p>
          <a:p>
            <a:r>
              <a:rPr lang="en-CA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sed as reference temperature.</a:t>
            </a:r>
          </a:p>
          <a:p>
            <a:endParaRPr lang="en-CA" sz="1600" b="1" dirty="0"/>
          </a:p>
        </p:txBody>
      </p:sp>
    </p:spTree>
    <p:extLst>
      <p:ext uri="{BB962C8B-B14F-4D97-AF65-F5344CB8AC3E}">
        <p14:creationId xmlns:p14="http://schemas.microsoft.com/office/powerpoint/2010/main" val="27226183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88C7066-D5A6-31F9-C877-66A851994E8D}"/>
              </a:ext>
            </a:extLst>
          </p:cNvPr>
          <p:cNvGrpSpPr/>
          <p:nvPr/>
        </p:nvGrpSpPr>
        <p:grpSpPr>
          <a:xfrm>
            <a:off x="71350" y="246203"/>
            <a:ext cx="12618711" cy="6225148"/>
            <a:chOff x="773099" y="1107440"/>
            <a:chExt cx="12618711" cy="6225148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047D58B-348D-4D33-BB3D-48A1FC63C0A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213233" y="1223962"/>
              <a:ext cx="9020175" cy="4410075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86A120B-AE94-4F00-A07B-8ED0264596C3}"/>
                </a:ext>
              </a:extLst>
            </p:cNvPr>
            <p:cNvSpPr txBox="1"/>
            <p:nvPr/>
          </p:nvSpPr>
          <p:spPr>
            <a:xfrm>
              <a:off x="6251058" y="2237150"/>
              <a:ext cx="2152650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CA" b="1" dirty="0"/>
                <a:t>Spike</a:t>
              </a:r>
            </a:p>
            <a:p>
              <a:pPr algn="ctr"/>
              <a:r>
                <a:rPr lang="en-CA" b="1" dirty="0">
                  <a:solidFill>
                    <a:srgbClr val="FF0000"/>
                  </a:solidFill>
                </a:rPr>
                <a:t>SORP assay (ver-2)</a:t>
              </a:r>
              <a:r>
                <a:rPr lang="en-CA" b="1" dirty="0"/>
                <a:t> 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483ABB8-DD61-4EC9-835C-B258C26CEFE6}"/>
                </a:ext>
              </a:extLst>
            </p:cNvPr>
            <p:cNvSpPr txBox="1"/>
            <p:nvPr/>
          </p:nvSpPr>
          <p:spPr>
            <a:xfrm>
              <a:off x="8817949" y="2626457"/>
              <a:ext cx="2021753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CA" b="1" dirty="0"/>
                <a:t>Spike</a:t>
              </a:r>
              <a:r>
                <a:rPr lang="en-CA" dirty="0"/>
                <a:t>         </a:t>
              </a:r>
            </a:p>
            <a:p>
              <a:r>
                <a:rPr lang="en-CA" b="1" dirty="0">
                  <a:solidFill>
                    <a:srgbClr val="FF0000"/>
                  </a:solidFill>
                </a:rPr>
                <a:t>SORP assay (ver-1)</a:t>
              </a:r>
              <a:endParaRPr lang="en-CA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47E09A6-4BDD-43B5-8F14-A553CE5EC61C}"/>
                </a:ext>
              </a:extLst>
            </p:cNvPr>
            <p:cNvSpPr txBox="1"/>
            <p:nvPr/>
          </p:nvSpPr>
          <p:spPr>
            <a:xfrm>
              <a:off x="9749012" y="3710817"/>
              <a:ext cx="6383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b="1" dirty="0"/>
                <a:t>ORF8</a:t>
              </a: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ACB3B838-BEDC-4128-A919-AF8DA08A458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153145" y="3898669"/>
              <a:ext cx="614310" cy="241434"/>
            </a:xfrm>
            <a:prstGeom prst="straightConnector1">
              <a:avLst/>
            </a:prstGeom>
            <a:ln w="25400">
              <a:solidFill>
                <a:srgbClr val="FF0000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8"/>
            <p:cNvSpPr/>
            <p:nvPr/>
          </p:nvSpPr>
          <p:spPr>
            <a:xfrm>
              <a:off x="10896704" y="1107440"/>
              <a:ext cx="673407" cy="129985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D77A906-34B9-4F45-865B-C65BF2A19150}"/>
                </a:ext>
              </a:extLst>
            </p:cNvPr>
            <p:cNvSpPr txBox="1"/>
            <p:nvPr/>
          </p:nvSpPr>
          <p:spPr>
            <a:xfrm>
              <a:off x="773099" y="6224592"/>
              <a:ext cx="12618711" cy="1107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2400" b="1" dirty="0"/>
                <a:t>Fig. 5_Suppl:</a:t>
              </a:r>
              <a:r>
                <a:rPr lang="en-CA" sz="18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Representative example of a saline gargle sample, tested using extraction-free PCR using SORP assays, ver:1 and 2. </a:t>
              </a:r>
            </a:p>
            <a:p>
              <a:r>
                <a:rPr lang="en-CA" sz="18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nnealing temperature was kept at 60 °C. RFU: relative fluorescence units. </a:t>
              </a:r>
            </a:p>
            <a:p>
              <a:endParaRPr lang="en-CA" sz="2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483849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D77A906-34B9-4F45-865B-C65BF2A19150}"/>
              </a:ext>
            </a:extLst>
          </p:cNvPr>
          <p:cNvSpPr txBox="1"/>
          <p:nvPr/>
        </p:nvSpPr>
        <p:spPr>
          <a:xfrm>
            <a:off x="1657478" y="4965524"/>
            <a:ext cx="9426363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/>
              <a:t>Fig. 6_suppl: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rallel testing of a cohort of SARS-CoV-2 negative samples for RNase P using the</a:t>
            </a:r>
          </a:p>
          <a:p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.) US-CDC’s recommended RNase-P F/R and (B.) inefficient RNase-P F/R3.</a:t>
            </a:r>
          </a:p>
          <a:p>
            <a:endParaRPr lang="en-CA" sz="2400" b="1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1BBDF82-8C9A-45D9-8407-B20291D6E65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9038" y="383612"/>
            <a:ext cx="4424027" cy="2897909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9712D136-A08C-4FAB-830A-11176C262D24}"/>
              </a:ext>
            </a:extLst>
          </p:cNvPr>
          <p:cNvSpPr txBox="1"/>
          <p:nvPr/>
        </p:nvSpPr>
        <p:spPr>
          <a:xfrm>
            <a:off x="3882033" y="2279839"/>
            <a:ext cx="16868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/>
              <a:t> Avg C</a:t>
            </a:r>
            <a:r>
              <a:rPr lang="en-CA" sz="2000" b="1" baseline="-25000" dirty="0"/>
              <a:t>T</a:t>
            </a:r>
            <a:r>
              <a:rPr lang="en-CA" sz="2000" b="1" dirty="0"/>
              <a:t>= 28.76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914132" y="511965"/>
            <a:ext cx="530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.)</a:t>
            </a:r>
            <a:endParaRPr lang="en-CA" b="1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88906AF8-19F1-4EE7-FAD9-24D63C3D1981}"/>
              </a:ext>
            </a:extLst>
          </p:cNvPr>
          <p:cNvGrpSpPr/>
          <p:nvPr/>
        </p:nvGrpSpPr>
        <p:grpSpPr>
          <a:xfrm>
            <a:off x="6443900" y="303471"/>
            <a:ext cx="4389732" cy="3492352"/>
            <a:chOff x="1279038" y="3365648"/>
            <a:chExt cx="4389732" cy="3492352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D757DE91-1B60-464C-8646-5867BD04FA8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9038" y="3365648"/>
              <a:ext cx="4389732" cy="3492352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3556307-E98D-4C5F-86AD-26E16529BB80}"/>
                </a:ext>
              </a:extLst>
            </p:cNvPr>
            <p:cNvSpPr txBox="1"/>
            <p:nvPr/>
          </p:nvSpPr>
          <p:spPr>
            <a:xfrm>
              <a:off x="4039670" y="5373434"/>
              <a:ext cx="16291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2000" b="1" dirty="0"/>
                <a:t>Avg C</a:t>
              </a:r>
              <a:r>
                <a:rPr lang="en-CA" sz="2000" b="1" baseline="-25000" dirty="0"/>
                <a:t>T</a:t>
              </a:r>
              <a:r>
                <a:rPr lang="en-CA" sz="2000" b="1" dirty="0"/>
                <a:t>= 33.29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973217" y="3458353"/>
              <a:ext cx="5196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(B.)</a:t>
              </a:r>
              <a:endParaRPr lang="en-CA" b="1" dirty="0"/>
            </a:p>
          </p:txBody>
        </p:sp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8A56426D-3368-8513-B93F-2B45ECEA5E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54483" y="3586262"/>
            <a:ext cx="673135" cy="209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50137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F63384C0-0687-4E99-A207-A633DAECC3C6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326395" y="1012114"/>
            <a:ext cx="2563831" cy="216603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EAF0AE8-977E-4F5A-8FEC-7A95AF01C104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12913" y="1027407"/>
            <a:ext cx="2563831" cy="207503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1143D39-648D-4E78-938D-B8031CBBBF8A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4080" y="3467983"/>
            <a:ext cx="2602664" cy="212178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F725F15-EDC9-4038-B57D-D0AFF063FEC6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326395" y="3504961"/>
            <a:ext cx="2601533" cy="214638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F15E24E-2E28-48DF-932C-FEFA1C7A5EC3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9333406" y="3486068"/>
            <a:ext cx="2719374" cy="202625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1D000FA-A090-43F6-91A3-415F3453C357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6277753" y="1104477"/>
            <a:ext cx="2605428" cy="199796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347E2FE-7D01-4D92-84B3-C02B74DFAF77}"/>
              </a:ext>
            </a:extLst>
          </p:cNvPr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9465321" y="1079528"/>
            <a:ext cx="2587459" cy="205368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0A3AAFD-C616-4BCE-B07C-0DCDB6935F5E}"/>
              </a:ext>
            </a:extLst>
          </p:cNvPr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6277753" y="3467175"/>
            <a:ext cx="2601533" cy="2064039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6801110-B5E0-45EA-98EA-FABF026A42BE}"/>
              </a:ext>
            </a:extLst>
          </p:cNvPr>
          <p:cNvSpPr txBox="1"/>
          <p:nvPr/>
        </p:nvSpPr>
        <p:spPr>
          <a:xfrm>
            <a:off x="4065559" y="280278"/>
            <a:ext cx="143564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b="1" dirty="0"/>
              <a:t> SORP ver2</a:t>
            </a:r>
          </a:p>
          <a:p>
            <a:r>
              <a:rPr lang="en-CA" sz="1200" b="1" dirty="0"/>
              <a:t>(Inefficient RNaseP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3B92E1A-D0A8-4304-9908-C8A5D4394AB0}"/>
              </a:ext>
            </a:extLst>
          </p:cNvPr>
          <p:cNvSpPr txBox="1"/>
          <p:nvPr/>
        </p:nvSpPr>
        <p:spPr>
          <a:xfrm>
            <a:off x="900291" y="386797"/>
            <a:ext cx="11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SORP ver2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3B770C1-3862-4332-9FEE-170637D9D40D}"/>
              </a:ext>
            </a:extLst>
          </p:cNvPr>
          <p:cNvCxnSpPr>
            <a:cxnSpLocks/>
          </p:cNvCxnSpPr>
          <p:nvPr/>
        </p:nvCxnSpPr>
        <p:spPr>
          <a:xfrm flipH="1">
            <a:off x="6068291" y="541391"/>
            <a:ext cx="52183" cy="4870194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Arrow: Right 1">
            <a:extLst>
              <a:ext uri="{FF2B5EF4-FFF2-40B4-BE49-F238E27FC236}">
                <a16:creationId xmlns:a16="http://schemas.microsoft.com/office/drawing/2014/main" id="{4181123A-6915-4755-AC8C-517A56FDC118}"/>
              </a:ext>
            </a:extLst>
          </p:cNvPr>
          <p:cNvSpPr/>
          <p:nvPr/>
        </p:nvSpPr>
        <p:spPr>
          <a:xfrm>
            <a:off x="2676744" y="4254280"/>
            <a:ext cx="504523" cy="35582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" name="Arrow: Right 16">
            <a:extLst>
              <a:ext uri="{FF2B5EF4-FFF2-40B4-BE49-F238E27FC236}">
                <a16:creationId xmlns:a16="http://schemas.microsoft.com/office/drawing/2014/main" id="{5A6D9CC1-D294-4D2F-A29B-DA15DAB6B4C4}"/>
              </a:ext>
            </a:extLst>
          </p:cNvPr>
          <p:cNvSpPr/>
          <p:nvPr/>
        </p:nvSpPr>
        <p:spPr>
          <a:xfrm>
            <a:off x="2755384" y="1679291"/>
            <a:ext cx="504523" cy="35582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" name="Arrow: Right 1">
            <a:extLst>
              <a:ext uri="{FF2B5EF4-FFF2-40B4-BE49-F238E27FC236}">
                <a16:creationId xmlns:a16="http://schemas.microsoft.com/office/drawing/2014/main" id="{4181123A-6915-4755-AC8C-517A56FDC118}"/>
              </a:ext>
            </a:extLst>
          </p:cNvPr>
          <p:cNvSpPr/>
          <p:nvPr/>
        </p:nvSpPr>
        <p:spPr>
          <a:xfrm>
            <a:off x="8960798" y="1762772"/>
            <a:ext cx="504523" cy="35582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3" name="Arrow: Right 1">
            <a:extLst>
              <a:ext uri="{FF2B5EF4-FFF2-40B4-BE49-F238E27FC236}">
                <a16:creationId xmlns:a16="http://schemas.microsoft.com/office/drawing/2014/main" id="{4181123A-6915-4755-AC8C-517A56FDC118}"/>
              </a:ext>
            </a:extLst>
          </p:cNvPr>
          <p:cNvSpPr/>
          <p:nvPr/>
        </p:nvSpPr>
        <p:spPr>
          <a:xfrm>
            <a:off x="8883727" y="4143375"/>
            <a:ext cx="504523" cy="35582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D77A906-34B9-4F45-865B-C65BF2A19150}"/>
              </a:ext>
            </a:extLst>
          </p:cNvPr>
          <p:cNvSpPr txBox="1"/>
          <p:nvPr/>
        </p:nvSpPr>
        <p:spPr>
          <a:xfrm>
            <a:off x="1595654" y="5690496"/>
            <a:ext cx="10239663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/>
              <a:t>Fig. 7_suppl: 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example of SARS-CoV-2 positive samples amplified using SORP ver 2 triplex assay. </a:t>
            </a:r>
          </a:p>
          <a:p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nel A, B, C and D depict triplex amplification using the US-CDC’s design of RNase P (F/R combination. The same sample </a:t>
            </a:r>
          </a:p>
          <a:p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plified under same conditions expect the RNase-P R3 was used for “in efficient” amplification of the internal control</a:t>
            </a:r>
          </a:p>
          <a:p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1, B1, C1 and D1).</a:t>
            </a:r>
            <a:endParaRPr lang="en-CA" sz="20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3B92E1A-D0A8-4304-9908-C8A5D4394AB0}"/>
              </a:ext>
            </a:extLst>
          </p:cNvPr>
          <p:cNvSpPr txBox="1"/>
          <p:nvPr/>
        </p:nvSpPr>
        <p:spPr>
          <a:xfrm>
            <a:off x="7257377" y="372611"/>
            <a:ext cx="11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SORP ver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6801110-B5E0-45EA-98EA-FABF026A42BE}"/>
              </a:ext>
            </a:extLst>
          </p:cNvPr>
          <p:cNvSpPr txBox="1"/>
          <p:nvPr/>
        </p:nvSpPr>
        <p:spPr>
          <a:xfrm>
            <a:off x="10144688" y="318264"/>
            <a:ext cx="143564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b="1" dirty="0"/>
              <a:t> SORP ver2</a:t>
            </a:r>
          </a:p>
          <a:p>
            <a:r>
              <a:rPr lang="en-CA" sz="1200" b="1" dirty="0"/>
              <a:t>(Inefficient RNaseP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1712950" y="2707714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1</a:t>
            </a:r>
            <a:endParaRPr lang="en-CA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8545914" y="261562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  <a:endParaRPr lang="en-CA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5501208" y="5161882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1</a:t>
            </a:r>
            <a:endParaRPr lang="en-CA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5455492" y="273311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1</a:t>
            </a:r>
            <a:endParaRPr lang="en-CA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2359028" y="267107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en-CA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2305303" y="514298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en-CA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8536296" y="5042253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  <a:endParaRPr lang="en-CA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11613141" y="5055306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1</a:t>
            </a:r>
            <a:endParaRPr lang="en-CA" b="1" dirty="0"/>
          </a:p>
        </p:txBody>
      </p:sp>
    </p:spTree>
    <p:extLst>
      <p:ext uri="{BB962C8B-B14F-4D97-AF65-F5344CB8AC3E}">
        <p14:creationId xmlns:p14="http://schemas.microsoft.com/office/powerpoint/2010/main" val="657753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5</TotalTime>
  <Words>873</Words>
  <Application>Microsoft Office PowerPoint</Application>
  <PresentationFormat>Widescreen</PresentationFormat>
  <Paragraphs>201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 g</dc:creator>
  <cp:lastModifiedBy>V g</cp:lastModifiedBy>
  <cp:revision>3</cp:revision>
  <dcterms:created xsi:type="dcterms:W3CDTF">2022-05-09T00:04:33Z</dcterms:created>
  <dcterms:modified xsi:type="dcterms:W3CDTF">2023-01-12T01:18:12Z</dcterms:modified>
</cp:coreProperties>
</file>